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1680" cy="4005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>
              <a:lnSpc>
                <a:spcPct val="92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755640" y="5078160"/>
            <a:ext cx="6045120" cy="48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278240" y="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3"/>
          </p:nvPr>
        </p:nvSpPr>
        <p:spPr>
          <a:xfrm>
            <a:off x="4278240" y="10156680"/>
            <a:ext cx="32781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pt-B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6F036E7B-ED91-4FC6-9ABE-0DF9F485A6B4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D4E9BCB0-6AE1-410F-B234-469B16FB5169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3320" cy="400824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97B400-1C8C-46CC-A8FC-3CF1DADBBC3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6992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9480" y="3967560"/>
            <a:ext cx="1096992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52F41D8-6473-4ADE-999B-346F63454E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308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9480" y="396756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30880" y="396756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DCE36FD-A550-4CE0-9ABD-0689D5C938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18560" y="160488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27280" y="160488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9480" y="396756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18560" y="396756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27280" y="3967560"/>
            <a:ext cx="353196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83015C8-2325-46E6-9237-B8894279539C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6992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58BB5A3-96E7-4545-9841-E021403534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6992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9C20209-0D0C-44EF-AB7D-BC2A8A2786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20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30880" y="1604880"/>
            <a:ext cx="535320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A5FA0EE-5A40-451E-BD6A-4E1FCA9E56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6098828-1E8F-4979-AF16-5766422350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23880" y="1122120"/>
            <a:ext cx="9141120" cy="1105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DC54743-0B56-4136-87C2-A1F48AB2F3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30880" y="1604880"/>
            <a:ext cx="535320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9480" y="396756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DC35C85-F148-4A98-B39E-EA6A0EF421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20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308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30880" y="396756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1C50047-4999-4335-9349-1FB0170F11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30880" y="1604880"/>
            <a:ext cx="535320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9480" y="3967560"/>
            <a:ext cx="10969920" cy="215748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538E7C5-6987-49F7-9F5A-9E56E76125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23880" y="1122120"/>
            <a:ext cx="9141120" cy="238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b">
            <a:noAutofit/>
          </a:bodyPr>
          <a:p>
            <a:pPr indent="0">
              <a:lnSpc>
                <a:spcPct val="92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 idx="1"/>
          </p:nvPr>
        </p:nvSpPr>
        <p:spPr>
          <a:xfrm>
            <a:off x="838080" y="6356160"/>
            <a:ext cx="2740320" cy="36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pt-BR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9/03/1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sldNum" idx="2"/>
          </p:nvPr>
        </p:nvSpPr>
        <p:spPr>
          <a:xfrm>
            <a:off x="8610480" y="6356160"/>
            <a:ext cx="2740320" cy="36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pt-BR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BAF9EB39-0568-45EF-BE98-5B033B2F3707}" type="slidenum">
              <a:rPr b="0" lang="pt-BR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69920" cy="452304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2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"/>
          <p:cNvGrpSpPr/>
          <p:nvPr/>
        </p:nvGrpSpPr>
        <p:grpSpPr>
          <a:xfrm>
            <a:off x="1211400" y="1422360"/>
            <a:ext cx="1476360" cy="1042920"/>
            <a:chOff x="1211400" y="1422360"/>
            <a:chExt cx="1476360" cy="1042920"/>
          </a:xfrm>
        </p:grpSpPr>
        <p:sp>
          <p:nvSpPr>
            <p:cNvPr id="50" name=""/>
            <p:cNvSpPr/>
            <p:nvPr/>
          </p:nvSpPr>
          <p:spPr>
            <a:xfrm>
              <a:off x="1227240" y="1422360"/>
              <a:ext cx="1454040" cy="1042920"/>
            </a:xfrm>
            <a:prstGeom prst="rect">
              <a:avLst/>
            </a:prstGeom>
            <a:noFill/>
            <a:ln cap="sq" w="12600">
              <a:solidFill>
                <a:srgbClr val="43729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227240" y="1946160"/>
              <a:ext cx="1454040" cy="0"/>
            </a:xfrm>
            <a:prstGeom prst="line">
              <a:avLst/>
            </a:prstGeom>
            <a:ln cap="sq"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227240" y="1685880"/>
              <a:ext cx="1454040" cy="0"/>
            </a:xfrm>
            <a:prstGeom prst="line">
              <a:avLst/>
            </a:prstGeom>
            <a:ln cap="sq" w="28440">
              <a:solidFill>
                <a:srgbClr val="ed7d3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227240" y="1735200"/>
              <a:ext cx="1454040" cy="0"/>
            </a:xfrm>
            <a:prstGeom prst="line">
              <a:avLst/>
            </a:prstGeom>
            <a:ln cap="sq" w="28440">
              <a:solidFill>
                <a:srgbClr val="ed7d3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231920" y="1887480"/>
              <a:ext cx="1455840" cy="0"/>
            </a:xfrm>
            <a:prstGeom prst="line">
              <a:avLst/>
            </a:prstGeom>
            <a:ln cap="sq" w="28440">
              <a:solidFill>
                <a:srgbClr val="ed7d3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227240" y="1512720"/>
              <a:ext cx="1454040" cy="0"/>
            </a:xfrm>
            <a:prstGeom prst="line">
              <a:avLst/>
            </a:prstGeom>
            <a:ln cap="sq" w="28440">
              <a:solidFill>
                <a:srgbClr val="ed7d3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224000" y="2093760"/>
              <a:ext cx="1454040" cy="0"/>
            </a:xfrm>
            <a:prstGeom prst="line">
              <a:avLst/>
            </a:prstGeom>
            <a:ln cap="sq" w="28440">
              <a:solidFill>
                <a:srgbClr val="c55a1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27240" y="2246400"/>
              <a:ext cx="1454040" cy="0"/>
            </a:xfrm>
            <a:prstGeom prst="line">
              <a:avLst/>
            </a:prstGeom>
            <a:ln cap="sq" w="28440">
              <a:solidFill>
                <a:srgbClr val="c55a1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231920" y="2292480"/>
              <a:ext cx="1455840" cy="0"/>
            </a:xfrm>
            <a:prstGeom prst="line">
              <a:avLst/>
            </a:prstGeom>
            <a:ln cap="sq" w="28440">
              <a:solidFill>
                <a:srgbClr val="c55a1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211400" y="2336760"/>
              <a:ext cx="1455480" cy="0"/>
            </a:xfrm>
            <a:prstGeom prst="line">
              <a:avLst/>
            </a:prstGeom>
            <a:ln cap="sq" w="28440">
              <a:solidFill>
                <a:srgbClr val="c55a1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"/>
          <p:cNvSpPr/>
          <p:nvPr/>
        </p:nvSpPr>
        <p:spPr>
          <a:xfrm>
            <a:off x="782640" y="1506600"/>
            <a:ext cx="282960" cy="82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84360" y="1025640"/>
            <a:ext cx="21816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Training set (32 obs, </a:t>
            </a:r>
            <a:r>
              <a:rPr b="0" lang="pt-BR" sz="1400" spc="-1" strike="noStrike">
                <a:solidFill>
                  <a:srgbClr val="000000"/>
                </a:solidFill>
                <a:latin typeface="Symbol"/>
              </a:rPr>
              <a:t>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80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78120" y="434880"/>
            <a:ext cx="1976040" cy="94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Random sele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of 4 subjects with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each DSM group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(20% stratified sampling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844720" y="1801800"/>
            <a:ext cx="682560" cy="222120"/>
          </a:xfrm>
          <a:prstGeom prst="rightArrow">
            <a:avLst>
              <a:gd name="adj1" fmla="val 50000"/>
              <a:gd name="adj2" fmla="val 76823"/>
            </a:avLst>
          </a:prstGeom>
          <a:solidFill>
            <a:srgbClr val="5b9bd5"/>
          </a:solidFill>
          <a:ln cap="sq" w="12600">
            <a:solidFill>
              <a:srgbClr val="43729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711600" y="1506600"/>
            <a:ext cx="1457280" cy="811080"/>
          </a:xfrm>
          <a:prstGeom prst="rect">
            <a:avLst/>
          </a:prstGeom>
          <a:noFill/>
          <a:ln cap="sq" w="12600">
            <a:solidFill>
              <a:srgbClr val="43729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711600" y="1911240"/>
            <a:ext cx="1457280" cy="1800"/>
          </a:xfrm>
          <a:prstGeom prst="line">
            <a:avLst/>
          </a:prstGeom>
          <a:ln cap="sq"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261040" y="1778040"/>
            <a:ext cx="5708520" cy="222120"/>
          </a:xfrm>
          <a:prstGeom prst="rightArrow">
            <a:avLst>
              <a:gd name="adj1" fmla="val 50000"/>
              <a:gd name="adj2" fmla="val 642504"/>
            </a:avLst>
          </a:prstGeom>
          <a:solidFill>
            <a:srgbClr val="5b9bd5"/>
          </a:solidFill>
          <a:ln cap="sq" w="12600">
            <a:solidFill>
              <a:srgbClr val="43729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218560" y="1998720"/>
            <a:ext cx="1037160" cy="115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CL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(method=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directional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squar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correlatio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555960" y="2000160"/>
            <a:ext cx="2100960" cy="72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Using 1LV, 2LV,…, 6LV,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cluster subjects (k-means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into 2 group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9090000" y="2000160"/>
            <a:ext cx="2979720" cy="286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Choice of a number A of LV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(for instance the lowest number of LV for which the agreement with DSM group for training set is maximu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Each of the A LVs are linear combinations of variables. A vector of loadings wa (a=1,…,A) is associated with each L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Two centers (c1, c2) are also defined by the k-means clustering based on the A LV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110120" y="1654200"/>
            <a:ext cx="67608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Calibri"/>
              </a:rPr>
              <a:t>Xtr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836720" y="2671920"/>
            <a:ext cx="225360" cy="728640"/>
          </a:xfrm>
          <a:prstGeom prst="downArrow">
            <a:avLst>
              <a:gd name="adj1" fmla="val 50000"/>
              <a:gd name="adj2" fmla="val 80831"/>
            </a:avLst>
          </a:prstGeom>
          <a:solidFill>
            <a:srgbClr val="f8cbad"/>
          </a:solidFill>
          <a:ln cap="sq" w="12600">
            <a:solidFill>
              <a:srgbClr val="f4b1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224000" y="3627360"/>
            <a:ext cx="1440000" cy="168480"/>
          </a:xfrm>
          <a:prstGeom prst="rect">
            <a:avLst/>
          </a:prstGeom>
          <a:solidFill>
            <a:srgbClr val="ed7d31"/>
          </a:solidFill>
          <a:ln cap="sq" w="12600">
            <a:solidFill>
              <a:srgbClr val="ed7d3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069920" y="3289320"/>
            <a:ext cx="202572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600" spc="-1" strike="noStrike">
                <a:solidFill>
                  <a:srgbClr val="000000"/>
                </a:solidFill>
                <a:latin typeface="Calibri"/>
              </a:rPr>
              <a:t>Test Set (8obs, </a:t>
            </a:r>
            <a:r>
              <a:rPr b="0" lang="pt-BR" sz="1600" spc="-1" strike="noStrike">
                <a:solidFill>
                  <a:srgbClr val="000000"/>
                </a:solidFill>
                <a:latin typeface="Symbol"/>
              </a:rPr>
              <a:t></a:t>
            </a:r>
            <a:r>
              <a:rPr b="0" lang="pt-BR" sz="1600" spc="-1" strike="noStrike">
                <a:solidFill>
                  <a:srgbClr val="000000"/>
                </a:solidFill>
                <a:latin typeface="Calibri"/>
              </a:rPr>
              <a:t>20%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220760" y="3795840"/>
            <a:ext cx="1441440" cy="222120"/>
          </a:xfrm>
          <a:prstGeom prst="rect">
            <a:avLst/>
          </a:prstGeom>
          <a:solidFill>
            <a:srgbClr val="c55a11"/>
          </a:solidFill>
          <a:ln cap="sq" w="12600">
            <a:solidFill>
              <a:srgbClr val="c55a1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5400000">
            <a:off x="2355120" y="3690000"/>
            <a:ext cx="528480" cy="1555920"/>
          </a:xfrm>
          <a:custGeom>
            <a:avLst/>
            <a:gdLst>
              <a:gd name="textAreaLeft" fmla="*/ 0 w 528480"/>
              <a:gd name="textAreaRight" fmla="*/ 452880 w 528480"/>
              <a:gd name="textAreaTop" fmla="*/ 1046520 h 1555920"/>
              <a:gd name="textAreaBottom" fmla="*/ 1556280 h 1555920"/>
            </a:gdLst>
            <a:ahLst/>
            <a:rect l="textAreaLeft" t="textAreaTop" r="textAreaRight" b="textAreaBottom"/>
            <a:pathLst>
              <a:path w="21600" h="21600">
                <a:moveTo>
                  <a:pt x="15470" y="0"/>
                </a:moveTo>
                <a:lnTo>
                  <a:pt x="9340" y="7200"/>
                </a:lnTo>
                <a:lnTo>
                  <a:pt x="12440" y="7200"/>
                </a:lnTo>
                <a:lnTo>
                  <a:pt x="12440" y="14525"/>
                </a:lnTo>
                <a:lnTo>
                  <a:pt x="0" y="14525"/>
                </a:lnTo>
                <a:lnTo>
                  <a:pt x="0" y="21600"/>
                </a:lnTo>
                <a:lnTo>
                  <a:pt x="18500" y="21600"/>
                </a:lnTo>
                <a:lnTo>
                  <a:pt x="18500" y="7200"/>
                </a:lnTo>
                <a:lnTo>
                  <a:pt x="21600" y="7200"/>
                </a:lnTo>
                <a:lnTo>
                  <a:pt x="15470" y="0"/>
                </a:lnTo>
                <a:close/>
              </a:path>
            </a:pathLst>
          </a:custGeom>
          <a:solidFill>
            <a:srgbClr val="f8cba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242120" y="4467240"/>
            <a:ext cx="1747800" cy="272880"/>
          </a:xfrm>
          <a:prstGeom prst="leftArrow">
            <a:avLst>
              <a:gd name="adj1" fmla="val 50000"/>
              <a:gd name="adj2" fmla="val 160125"/>
            </a:avLst>
          </a:prstGeom>
          <a:solidFill>
            <a:srgbClr val="f8cba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04720" y="434880"/>
            <a:ext cx="11565000" cy="5761080"/>
          </a:xfrm>
          <a:prstGeom prst="rect">
            <a:avLst/>
          </a:prstGeom>
          <a:noFill/>
          <a:ln cap="sq"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20920" y="65160"/>
            <a:ext cx="50666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pt-BR" sz="1800" spc="-1" strike="noStrike">
                <a:solidFill>
                  <a:srgbClr val="000000"/>
                </a:solidFill>
                <a:latin typeface="Calibri"/>
              </a:rPr>
              <a:t>NREP repetitions of this cross-validation procedur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527280" y="3541680"/>
            <a:ext cx="3506760" cy="243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The scores of the observations in the test set, on the A Lvs, are defined : LVtest a=Xtest x 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Euclidean distances are calculated between the test obs and the centers c1 and c2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pt-BR" sz="1400" spc="-1" strike="noStrike">
                <a:solidFill>
                  <a:srgbClr val="000000"/>
                </a:solidFill>
                <a:latin typeface="Calibri"/>
              </a:rPr>
              <a:t>Min distance rule is used to allocate each test obs to a cluster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i="1" lang="pt-BR" sz="1400" spc="-1" strike="noStrike">
                <a:solidFill>
                  <a:srgbClr val="000000"/>
                </a:solidFill>
                <a:latin typeface="Calibri"/>
              </a:rPr>
              <a:t>Agreement between DSM group and predicted group for the test observations  is evaluat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Evelyne Vigneau</dc:creator>
  <dc:description/>
  <dc:language>en-US</dc:language>
  <cp:lastModifiedBy>Evelyne Vigneau</cp:lastModifiedBy>
  <dcterms:modified xsi:type="dcterms:W3CDTF">2019-03-19T14:29:36Z</dcterms:modified>
  <cp:revision>1</cp:revision>
  <dc:subject/>
  <dc:title>Présentation PowerPoint</dc:title>
</cp:coreProperties>
</file>